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2.xml" ContentType="application/vnd.ms-office.chartstyle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59" d="100"/>
          <a:sy n="59" d="100"/>
        </p:scale>
        <p:origin x="-1056" y="-2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thail\OneDrive\&#193;rea%20de%20Trabalho\GG%202020\Guilherme\MS%20GPCRs\Final\glicose%20e%20DW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thail\OneDrive\&#193;rea%20de%20Trabalho\GG%202020\Guilherme\MS%20GPCRs\Final\glicose%20e%20D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t-B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DW!$B$23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errBars>
            <c:errBarType val="plus"/>
            <c:errValType val="cust"/>
            <c:plus>
              <c:numRef>
                <c:f>DW!$D$24:$D$29</c:f>
                <c:numCache>
                  <c:formatCode>General</c:formatCode>
                  <c:ptCount val="6"/>
                  <c:pt idx="0">
                    <c:v>2.0548046676563256</c:v>
                  </c:pt>
                  <c:pt idx="1">
                    <c:v>2.8674417556808756</c:v>
                  </c:pt>
                  <c:pt idx="2">
                    <c:v>1.6996731711975954</c:v>
                  </c:pt>
                  <c:pt idx="3">
                    <c:v>4.2426406871192865</c:v>
                  </c:pt>
                  <c:pt idx="4">
                    <c:v>5.5577773335110221</c:v>
                  </c:pt>
                  <c:pt idx="5">
                    <c:v>3.85861230093007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DW!$A$24:$A$29</c:f>
              <c:strCache>
                <c:ptCount val="6"/>
                <c:pt idx="0">
                  <c:v>WT</c:v>
                </c:pt>
                <c:pt idx="1">
                  <c:v>DgprM</c:v>
                </c:pt>
                <c:pt idx="2">
                  <c:v>gprM+</c:v>
                </c:pt>
                <c:pt idx="3">
                  <c:v>DgprJ</c:v>
                </c:pt>
                <c:pt idx="4">
                  <c:v>gprJ+</c:v>
                </c:pt>
                <c:pt idx="5">
                  <c:v>DgprMDgprJ</c:v>
                </c:pt>
              </c:strCache>
            </c:strRef>
          </c:cat>
          <c:val>
            <c:numRef>
              <c:f>DW!$B$24:$B$29</c:f>
              <c:numCache>
                <c:formatCode>General</c:formatCode>
                <c:ptCount val="6"/>
                <c:pt idx="0">
                  <c:v>29.666666666666668</c:v>
                </c:pt>
                <c:pt idx="1">
                  <c:v>31.333333333333318</c:v>
                </c:pt>
                <c:pt idx="2">
                  <c:v>30.666666666666668</c:v>
                </c:pt>
                <c:pt idx="3">
                  <c:v>36</c:v>
                </c:pt>
                <c:pt idx="4">
                  <c:v>39.666666666666636</c:v>
                </c:pt>
                <c:pt idx="5">
                  <c:v>35.66666666666663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1F5-4FCF-B60D-6DDD25E6020B}"/>
            </c:ext>
          </c:extLst>
        </c:ser>
        <c:ser>
          <c:idx val="1"/>
          <c:order val="1"/>
          <c:tx>
            <c:strRef>
              <c:f>DW!$C$23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</a:ln>
            <a:effectLst/>
          </c:spPr>
          <c:errBars>
            <c:errBarType val="plus"/>
            <c:errValType val="cust"/>
            <c:plus>
              <c:numRef>
                <c:f>DW!$E$24:$E$29</c:f>
                <c:numCache>
                  <c:formatCode>General</c:formatCode>
                  <c:ptCount val="6"/>
                  <c:pt idx="0">
                    <c:v>8.7305339024725264</c:v>
                  </c:pt>
                  <c:pt idx="1">
                    <c:v>5.4365021434333682</c:v>
                  </c:pt>
                  <c:pt idx="2">
                    <c:v>2.4944382578492941</c:v>
                  </c:pt>
                  <c:pt idx="3">
                    <c:v>3.5590260840104371</c:v>
                  </c:pt>
                  <c:pt idx="4">
                    <c:v>8.9566858950296098</c:v>
                  </c:pt>
                  <c:pt idx="5">
                    <c:v>6.23609564462323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DW!$A$24:$A$29</c:f>
              <c:strCache>
                <c:ptCount val="6"/>
                <c:pt idx="0">
                  <c:v>WT</c:v>
                </c:pt>
                <c:pt idx="1">
                  <c:v>DgprM</c:v>
                </c:pt>
                <c:pt idx="2">
                  <c:v>gprM+</c:v>
                </c:pt>
                <c:pt idx="3">
                  <c:v>DgprJ</c:v>
                </c:pt>
                <c:pt idx="4">
                  <c:v>gprJ+</c:v>
                </c:pt>
                <c:pt idx="5">
                  <c:v>DgprMDgprJ</c:v>
                </c:pt>
              </c:strCache>
            </c:strRef>
          </c:cat>
          <c:val>
            <c:numRef>
              <c:f>DW!$C$24:$C$29</c:f>
              <c:numCache>
                <c:formatCode>General</c:formatCode>
                <c:ptCount val="6"/>
                <c:pt idx="0">
                  <c:v>114.3333333333333</c:v>
                </c:pt>
                <c:pt idx="1">
                  <c:v>105.66666666666667</c:v>
                </c:pt>
                <c:pt idx="2">
                  <c:v>108.66666666666667</c:v>
                </c:pt>
                <c:pt idx="3">
                  <c:v>105</c:v>
                </c:pt>
                <c:pt idx="4">
                  <c:v>112.66666666666667</c:v>
                </c:pt>
                <c:pt idx="5">
                  <c:v>113.3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1F5-4FCF-B60D-6DDD25E6020B}"/>
            </c:ext>
          </c:extLst>
        </c:ser>
        <c:gapWidth val="219"/>
        <c:overlap val="-27"/>
        <c:axId val="97717632"/>
        <c:axId val="97744000"/>
      </c:barChart>
      <c:catAx>
        <c:axId val="97717632"/>
        <c:scaling>
          <c:orientation val="minMax"/>
        </c:scaling>
        <c:axPos val="b"/>
        <c:numFmt formatCode="General" sourceLinked="1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pt-BR"/>
          </a:p>
        </c:txPr>
        <c:crossAx val="97744000"/>
        <c:crosses val="autoZero"/>
        <c:auto val="1"/>
        <c:lblAlgn val="ctr"/>
        <c:lblOffset val="100"/>
      </c:catAx>
      <c:valAx>
        <c:axId val="97744000"/>
        <c:scaling>
          <c:orientation val="minMax"/>
        </c:scaling>
        <c:axPos val="l"/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pt-BR"/>
          </a:p>
        </c:txPr>
        <c:crossAx val="97717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pt-BR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t-BR"/>
  <c:style val="5"/>
  <c:chart>
    <c:plotArea>
      <c:layout/>
      <c:barChart>
        <c:barDir val="col"/>
        <c:grouping val="clustered"/>
        <c:ser>
          <c:idx val="0"/>
          <c:order val="0"/>
          <c:tx>
            <c:strRef>
              <c:f>'grafico glicose'!$A$20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errBars>
            <c:errBarType val="plus"/>
            <c:errValType val="cust"/>
            <c:plus>
              <c:numRef>
                <c:f>'grafico glicose'!$B$28:$G$2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7002660220607972</c:v>
                  </c:pt>
                  <c:pt idx="2">
                    <c:v>3.9702905171297087</c:v>
                  </c:pt>
                  <c:pt idx="3">
                    <c:v>1.2030946566320415</c:v>
                  </c:pt>
                  <c:pt idx="4">
                    <c:v>1.1220838040464822</c:v>
                  </c:pt>
                  <c:pt idx="5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afico glicose'!$B$19:$G$19</c:f>
              <c:strCache>
                <c:ptCount val="6"/>
                <c:pt idx="0">
                  <c:v>0</c:v>
                </c:pt>
                <c:pt idx="1">
                  <c:v>20h</c:v>
                </c:pt>
                <c:pt idx="2">
                  <c:v>24h</c:v>
                </c:pt>
                <c:pt idx="3">
                  <c:v>28h</c:v>
                </c:pt>
                <c:pt idx="4">
                  <c:v>32h</c:v>
                </c:pt>
                <c:pt idx="5">
                  <c:v>44h</c:v>
                </c:pt>
              </c:strCache>
            </c:strRef>
          </c:cat>
          <c:val>
            <c:numRef>
              <c:f>'grafico glicose'!$B$20:$G$20</c:f>
              <c:numCache>
                <c:formatCode>General</c:formatCode>
                <c:ptCount val="6"/>
                <c:pt idx="0">
                  <c:v>100</c:v>
                </c:pt>
                <c:pt idx="1">
                  <c:v>85.729642600692586</c:v>
                </c:pt>
                <c:pt idx="2">
                  <c:v>84.70434361178971</c:v>
                </c:pt>
                <c:pt idx="3">
                  <c:v>70.372128459768888</c:v>
                </c:pt>
                <c:pt idx="4">
                  <c:v>21.62648510164405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78A-494B-8FDE-84134EAC1972}"/>
            </c:ext>
          </c:extLst>
        </c:ser>
        <c:ser>
          <c:idx val="1"/>
          <c:order val="1"/>
          <c:tx>
            <c:strRef>
              <c:f>'grafico glicose'!$A$21</c:f>
              <c:strCache>
                <c:ptCount val="1"/>
                <c:pt idx="0">
                  <c:v>ΔgprM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errBars>
            <c:errBarType val="plus"/>
            <c:errValType val="cust"/>
            <c:plus>
              <c:numRef>
                <c:f>'grafico glicose'!$B$29:$G$2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95768028847329878</c:v>
                  </c:pt>
                  <c:pt idx="2">
                    <c:v>6.2654236751411228</c:v>
                  </c:pt>
                  <c:pt idx="3">
                    <c:v>1.4990962055660897</c:v>
                  </c:pt>
                  <c:pt idx="4">
                    <c:v>1.3991649770625099</c:v>
                  </c:pt>
                  <c:pt idx="5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afico glicose'!$B$19:$G$19</c:f>
              <c:strCache>
                <c:ptCount val="6"/>
                <c:pt idx="0">
                  <c:v>0</c:v>
                </c:pt>
                <c:pt idx="1">
                  <c:v>20h</c:v>
                </c:pt>
                <c:pt idx="2">
                  <c:v>24h</c:v>
                </c:pt>
                <c:pt idx="3">
                  <c:v>28h</c:v>
                </c:pt>
                <c:pt idx="4">
                  <c:v>32h</c:v>
                </c:pt>
                <c:pt idx="5">
                  <c:v>44h</c:v>
                </c:pt>
              </c:strCache>
            </c:strRef>
          </c:cat>
          <c:val>
            <c:numRef>
              <c:f>'grafico glicose'!$B$21:$F$21</c:f>
              <c:numCache>
                <c:formatCode>General</c:formatCode>
                <c:ptCount val="5"/>
                <c:pt idx="0">
                  <c:v>100</c:v>
                </c:pt>
                <c:pt idx="1">
                  <c:v>84.411401043531754</c:v>
                </c:pt>
                <c:pt idx="2">
                  <c:v>78.647756013056323</c:v>
                </c:pt>
                <c:pt idx="3">
                  <c:v>63.319536128958482</c:v>
                </c:pt>
                <c:pt idx="4">
                  <c:v>23.7869365425465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78A-494B-8FDE-84134EAC1972}"/>
            </c:ext>
          </c:extLst>
        </c:ser>
        <c:ser>
          <c:idx val="2"/>
          <c:order val="2"/>
          <c:tx>
            <c:strRef>
              <c:f>'grafico glicose'!$A$22</c:f>
              <c:strCache>
                <c:ptCount val="1"/>
                <c:pt idx="0">
                  <c:v>ΔgprM:gprM+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errBars>
            <c:errBarType val="plus"/>
            <c:errValType val="cust"/>
            <c:plus>
              <c:numRef>
                <c:f>'grafico glicose'!$B$30:$G$3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3560942984097939</c:v>
                  </c:pt>
                  <c:pt idx="2">
                    <c:v>1.9915112917958344</c:v>
                  </c:pt>
                  <c:pt idx="3">
                    <c:v>4.5638616506006153</c:v>
                  </c:pt>
                  <c:pt idx="4">
                    <c:v>2.2294810780029857</c:v>
                  </c:pt>
                  <c:pt idx="5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afico glicose'!$B$19:$G$19</c:f>
              <c:strCache>
                <c:ptCount val="6"/>
                <c:pt idx="0">
                  <c:v>0</c:v>
                </c:pt>
                <c:pt idx="1">
                  <c:v>20h</c:v>
                </c:pt>
                <c:pt idx="2">
                  <c:v>24h</c:v>
                </c:pt>
                <c:pt idx="3">
                  <c:v>28h</c:v>
                </c:pt>
                <c:pt idx="4">
                  <c:v>32h</c:v>
                </c:pt>
                <c:pt idx="5">
                  <c:v>44h</c:v>
                </c:pt>
              </c:strCache>
            </c:strRef>
          </c:cat>
          <c:val>
            <c:numRef>
              <c:f>'grafico glicose'!$B$22:$G$22</c:f>
              <c:numCache>
                <c:formatCode>General</c:formatCode>
                <c:ptCount val="6"/>
                <c:pt idx="0">
                  <c:v>100</c:v>
                </c:pt>
                <c:pt idx="1">
                  <c:v>86.901412873724368</c:v>
                </c:pt>
                <c:pt idx="2">
                  <c:v>86.483969713956839</c:v>
                </c:pt>
                <c:pt idx="3">
                  <c:v>68.907415618479106</c:v>
                </c:pt>
                <c:pt idx="4">
                  <c:v>27.997985961254731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78A-494B-8FDE-84134EAC1972}"/>
            </c:ext>
          </c:extLst>
        </c:ser>
        <c:ser>
          <c:idx val="3"/>
          <c:order val="3"/>
          <c:tx>
            <c:strRef>
              <c:f>'grafico glicose'!$A$23</c:f>
              <c:strCache>
                <c:ptCount val="1"/>
                <c:pt idx="0">
                  <c:v>ΔgprJ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errBars>
            <c:errBarType val="plus"/>
            <c:errValType val="cust"/>
            <c:plus>
              <c:numRef>
                <c:f>'grafico glicose'!$B$31:$G$3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9976019863418837</c:v>
                  </c:pt>
                  <c:pt idx="2">
                    <c:v>4.1962169604070532</c:v>
                  </c:pt>
                  <c:pt idx="3">
                    <c:v>4.7099116270819801</c:v>
                  </c:pt>
                  <c:pt idx="4">
                    <c:v>6.0236037346481117</c:v>
                  </c:pt>
                  <c:pt idx="5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afico glicose'!$B$19:$G$19</c:f>
              <c:strCache>
                <c:ptCount val="6"/>
                <c:pt idx="0">
                  <c:v>0</c:v>
                </c:pt>
                <c:pt idx="1">
                  <c:v>20h</c:v>
                </c:pt>
                <c:pt idx="2">
                  <c:v>24h</c:v>
                </c:pt>
                <c:pt idx="3">
                  <c:v>28h</c:v>
                </c:pt>
                <c:pt idx="4">
                  <c:v>32h</c:v>
                </c:pt>
                <c:pt idx="5">
                  <c:v>44h</c:v>
                </c:pt>
              </c:strCache>
            </c:strRef>
          </c:cat>
          <c:val>
            <c:numRef>
              <c:f>'grafico glicose'!$B$23:$G$23</c:f>
              <c:numCache>
                <c:formatCode>General</c:formatCode>
                <c:ptCount val="6"/>
                <c:pt idx="0">
                  <c:v>100</c:v>
                </c:pt>
                <c:pt idx="1">
                  <c:v>85.509935674499076</c:v>
                </c:pt>
                <c:pt idx="2">
                  <c:v>79.870791235533275</c:v>
                </c:pt>
                <c:pt idx="3">
                  <c:v>69.983979556827109</c:v>
                </c:pt>
                <c:pt idx="4">
                  <c:v>21.003982144095875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978A-494B-8FDE-84134EAC1972}"/>
            </c:ext>
          </c:extLst>
        </c:ser>
        <c:ser>
          <c:idx val="4"/>
          <c:order val="4"/>
          <c:tx>
            <c:strRef>
              <c:f>'grafico glicose'!$A$24</c:f>
              <c:strCache>
                <c:ptCount val="1"/>
                <c:pt idx="0">
                  <c:v>ΔgprJ:gprJ+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errBars>
            <c:errBarType val="plus"/>
            <c:errValType val="cust"/>
            <c:plus>
              <c:numRef>
                <c:f>'grafico glicose'!$B$32:$G$3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91177639069715</c:v>
                  </c:pt>
                  <c:pt idx="2">
                    <c:v>1.569021288665825</c:v>
                  </c:pt>
                  <c:pt idx="3">
                    <c:v>0.43616728471674032</c:v>
                  </c:pt>
                  <c:pt idx="4">
                    <c:v>4.2558667683629485</c:v>
                  </c:pt>
                  <c:pt idx="5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afico glicose'!$B$19:$G$19</c:f>
              <c:strCache>
                <c:ptCount val="6"/>
                <c:pt idx="0">
                  <c:v>0</c:v>
                </c:pt>
                <c:pt idx="1">
                  <c:v>20h</c:v>
                </c:pt>
                <c:pt idx="2">
                  <c:v>24h</c:v>
                </c:pt>
                <c:pt idx="3">
                  <c:v>28h</c:v>
                </c:pt>
                <c:pt idx="4">
                  <c:v>32h</c:v>
                </c:pt>
                <c:pt idx="5">
                  <c:v>44h</c:v>
                </c:pt>
              </c:strCache>
            </c:strRef>
          </c:cat>
          <c:val>
            <c:numRef>
              <c:f>'grafico glicose'!$B$24:$G$24</c:f>
              <c:numCache>
                <c:formatCode>General</c:formatCode>
                <c:ptCount val="6"/>
                <c:pt idx="0">
                  <c:v>100</c:v>
                </c:pt>
                <c:pt idx="1">
                  <c:v>84.850814895918703</c:v>
                </c:pt>
                <c:pt idx="2">
                  <c:v>82.360803065726003</c:v>
                </c:pt>
                <c:pt idx="3">
                  <c:v>62.389443474739423</c:v>
                </c:pt>
                <c:pt idx="4">
                  <c:v>25.544591952094287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978A-494B-8FDE-84134EAC1972}"/>
            </c:ext>
          </c:extLst>
        </c:ser>
        <c:ser>
          <c:idx val="5"/>
          <c:order val="5"/>
          <c:tx>
            <c:strRef>
              <c:f>'grafico glicose'!$A$25</c:f>
              <c:strCache>
                <c:ptCount val="1"/>
                <c:pt idx="0">
                  <c:v>ΔgprJ;ΔgprM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errBars>
            <c:errBarType val="plus"/>
            <c:errValType val="cust"/>
            <c:plus>
              <c:numRef>
                <c:f>'grafico glicose'!$B$33:$G$3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2144757300434199</c:v>
                  </c:pt>
                  <c:pt idx="2">
                    <c:v>5.6655567935553668</c:v>
                  </c:pt>
                  <c:pt idx="3">
                    <c:v>11.668317941837348</c:v>
                  </c:pt>
                  <c:pt idx="4">
                    <c:v>2.1209906792668147</c:v>
                  </c:pt>
                  <c:pt idx="5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afico glicose'!$B$19:$G$19</c:f>
              <c:strCache>
                <c:ptCount val="6"/>
                <c:pt idx="0">
                  <c:v>0</c:v>
                </c:pt>
                <c:pt idx="1">
                  <c:v>20h</c:v>
                </c:pt>
                <c:pt idx="2">
                  <c:v>24h</c:v>
                </c:pt>
                <c:pt idx="3">
                  <c:v>28h</c:v>
                </c:pt>
                <c:pt idx="4">
                  <c:v>32h</c:v>
                </c:pt>
                <c:pt idx="5">
                  <c:v>44h</c:v>
                </c:pt>
              </c:strCache>
            </c:strRef>
          </c:cat>
          <c:val>
            <c:numRef>
              <c:f>'grafico glicose'!$B$25:$G$25</c:f>
              <c:numCache>
                <c:formatCode>General</c:formatCode>
                <c:ptCount val="6"/>
                <c:pt idx="0">
                  <c:v>100</c:v>
                </c:pt>
                <c:pt idx="1">
                  <c:v>86.754941589595447</c:v>
                </c:pt>
                <c:pt idx="2">
                  <c:v>74.619795699509368</c:v>
                </c:pt>
                <c:pt idx="3">
                  <c:v>68.760944334350128</c:v>
                </c:pt>
                <c:pt idx="4">
                  <c:v>24.629146426288155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978A-494B-8FDE-84134EAC1972}"/>
            </c:ext>
          </c:extLst>
        </c:ser>
        <c:gapWidth val="219"/>
        <c:overlap val="-27"/>
        <c:axId val="98368896"/>
        <c:axId val="98251904"/>
      </c:barChart>
      <c:catAx>
        <c:axId val="98368896"/>
        <c:scaling>
          <c:orientation val="minMax"/>
        </c:scaling>
        <c:axPos val="b"/>
        <c:numFmt formatCode="General" sourceLinked="1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pt-BR"/>
          </a:p>
        </c:txPr>
        <c:crossAx val="98251904"/>
        <c:crosses val="autoZero"/>
        <c:auto val="1"/>
        <c:lblAlgn val="ctr"/>
        <c:lblOffset val="100"/>
      </c:catAx>
      <c:valAx>
        <c:axId val="98251904"/>
        <c:scaling>
          <c:orientation val="minMax"/>
          <c:max val="100"/>
        </c:scaling>
        <c:axPos val="l"/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pt-BR"/>
          </a:p>
        </c:txPr>
        <c:crossAx val="983688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8748169575681581"/>
          <c:y val="3.7924718597167055E-2"/>
          <c:w val="0.21120966227041968"/>
          <c:h val="0.4630699495231117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pt-BR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pt-BR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2D041B11-084E-44CA-9535-8FD8B5165A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="" xmlns:a16="http://schemas.microsoft.com/office/drawing/2014/main" id="{45414258-C17F-4D57-AB8F-D66B85C855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="" xmlns:a16="http://schemas.microsoft.com/office/drawing/2014/main" id="{AC29D9E6-9CD5-425D-BF64-4DB3B1407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="" xmlns:a16="http://schemas.microsoft.com/office/drawing/2014/main" id="{E491C1FA-3723-4B5F-9C6E-FBD567508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="" xmlns:a16="http://schemas.microsoft.com/office/drawing/2014/main" id="{6C1C438D-F25F-45F7-B939-C058FD61F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491446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3AB90A8B-2988-49C9-9F78-24432DF8DE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="" xmlns:a16="http://schemas.microsoft.com/office/drawing/2014/main" id="{8E55350B-7556-46F4-9BB2-0CB372651F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="" xmlns:a16="http://schemas.microsoft.com/office/drawing/2014/main" id="{F1C94D3D-5D0C-4A17-9476-447632092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="" xmlns:a16="http://schemas.microsoft.com/office/drawing/2014/main" id="{36417C0E-A7F4-424B-B483-93024F1FA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="" xmlns:a16="http://schemas.microsoft.com/office/drawing/2014/main" id="{44F3A2B7-F4B7-4A83-B295-7E587E072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576510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="" xmlns:a16="http://schemas.microsoft.com/office/drawing/2014/main" id="{D12860A1-FE84-4F4C-A95A-1DFFE1F161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="" xmlns:a16="http://schemas.microsoft.com/office/drawing/2014/main" id="{7BD2FC04-26DB-4FE0-94DC-BA78995445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="" xmlns:a16="http://schemas.microsoft.com/office/drawing/2014/main" id="{7A5504E1-302B-40B8-BA33-9E265040B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="" xmlns:a16="http://schemas.microsoft.com/office/drawing/2014/main" id="{10C9AE10-F351-48CB-8C12-ACA72FDD5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="" xmlns:a16="http://schemas.microsoft.com/office/drawing/2014/main" id="{0628EAD7-25BC-4795-AED7-1AFE3332A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933723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5FCBDFA1-2C79-48E0-ADAF-10D4D7CB4F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="" xmlns:a16="http://schemas.microsoft.com/office/drawing/2014/main" id="{38CFE844-89AC-41AA-8062-00016B6E7A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="" xmlns:a16="http://schemas.microsoft.com/office/drawing/2014/main" id="{DFE04BD8-022A-48C2-BFBE-51C97C662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="" xmlns:a16="http://schemas.microsoft.com/office/drawing/2014/main" id="{94D5D8C4-9CF0-4CC5-A587-E0EF0309B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="" xmlns:a16="http://schemas.microsoft.com/office/drawing/2014/main" id="{86B78340-9395-4DB7-B0BE-C7B4AB523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224117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0614DFAC-E168-4147-ADCD-8BC61C4746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="" xmlns:a16="http://schemas.microsoft.com/office/drawing/2014/main" id="{9134908A-709E-4689-82B4-3B7AC254EF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="" xmlns:a16="http://schemas.microsoft.com/office/drawing/2014/main" id="{A393977F-3F28-43A9-B70C-69351BEA6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="" xmlns:a16="http://schemas.microsoft.com/office/drawing/2014/main" id="{BC548196-1A0B-4E87-932B-93F0EEF93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="" xmlns:a16="http://schemas.microsoft.com/office/drawing/2014/main" id="{27B60359-3CC6-4F6F-8BB8-F8C6A3022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443089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86677597-5CA7-4DD1-89C8-FD95B2835D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="" xmlns:a16="http://schemas.microsoft.com/office/drawing/2014/main" id="{7C0752ED-AE50-4C38-BC79-5A8AD497BE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="" xmlns:a16="http://schemas.microsoft.com/office/drawing/2014/main" id="{F41AC779-22CD-4319-8683-D91EC63F78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="" xmlns:a16="http://schemas.microsoft.com/office/drawing/2014/main" id="{5B8AF2C9-7AD4-4638-9FA4-C3D0DB4BD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="" xmlns:a16="http://schemas.microsoft.com/office/drawing/2014/main" id="{2BE7588E-2E88-4C31-988C-2DC11D2D7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="" xmlns:a16="http://schemas.microsoft.com/office/drawing/2014/main" id="{CD2CA937-9EC7-4C84-8CF8-94FBCFDB2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476053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E8364C78-D165-46C4-B991-781471BF3B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="" xmlns:a16="http://schemas.microsoft.com/office/drawing/2014/main" id="{E71DC8DC-26AD-476A-B471-1F4A9BBEB8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="" xmlns:a16="http://schemas.microsoft.com/office/drawing/2014/main" id="{E2D6DE7C-0929-40B1-B2B5-C91AFC1430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="" xmlns:a16="http://schemas.microsoft.com/office/drawing/2014/main" id="{DC02E902-3EA3-4619-9829-7CA134F674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="" xmlns:a16="http://schemas.microsoft.com/office/drawing/2014/main" id="{17CDB730-A02D-436A-A9C7-9C72018A89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="" xmlns:a16="http://schemas.microsoft.com/office/drawing/2014/main" id="{D14B7E61-C255-45F2-922B-5DDC02017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="" xmlns:a16="http://schemas.microsoft.com/office/drawing/2014/main" id="{3B38F00A-426F-44A2-B0A3-02A861318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="" xmlns:a16="http://schemas.microsoft.com/office/drawing/2014/main" id="{32134512-534F-499E-83AD-78696AB50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537653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2CCBD8B3-04A1-4FD2-AFBA-5CA9F255B4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="" xmlns:a16="http://schemas.microsoft.com/office/drawing/2014/main" id="{39D22257-78BF-4F01-A195-928E7E511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="" xmlns:a16="http://schemas.microsoft.com/office/drawing/2014/main" id="{A0962D94-D24A-49F3-8D83-0270B49D4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="" xmlns:a16="http://schemas.microsoft.com/office/drawing/2014/main" id="{EF09D6AE-A172-40C5-8C7B-F9CCF4C28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76474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="" xmlns:a16="http://schemas.microsoft.com/office/drawing/2014/main" id="{828BE3FA-ADD3-4579-8458-C5E312D44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="" xmlns:a16="http://schemas.microsoft.com/office/drawing/2014/main" id="{1B1C5D87-30E3-4E1E-8198-B1162E032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="" xmlns:a16="http://schemas.microsoft.com/office/drawing/2014/main" id="{A82E4DA6-EBFA-493F-BCD0-D460DD5C8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371910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140308F9-AC84-427B-8D74-6B930AE8E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="" xmlns:a16="http://schemas.microsoft.com/office/drawing/2014/main" id="{BA7FA857-DFF4-4608-842B-60CAD1433A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="" xmlns:a16="http://schemas.microsoft.com/office/drawing/2014/main" id="{5A312B60-6A5A-4084-BBE4-B42715DD4C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="" xmlns:a16="http://schemas.microsoft.com/office/drawing/2014/main" id="{8311472C-5C6A-443B-8A17-51EFC0005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="" xmlns:a16="http://schemas.microsoft.com/office/drawing/2014/main" id="{0D641A0F-257E-4112-9375-1B2145DC8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="" xmlns:a16="http://schemas.microsoft.com/office/drawing/2014/main" id="{07B6BF41-2EB2-4AC7-AED0-072C17E1D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328682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D6706649-4B5F-4E38-9D62-65E14D5F3F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="" xmlns:a16="http://schemas.microsoft.com/office/drawing/2014/main" id="{8BC712CA-ED52-4DFF-A918-ED05E510B4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="" xmlns:a16="http://schemas.microsoft.com/office/drawing/2014/main" id="{C9D41B15-002F-4F30-9732-FF30C05FD1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="" xmlns:a16="http://schemas.microsoft.com/office/drawing/2014/main" id="{012F2FF2-C5CB-4B2A-B840-70C6532F7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="" xmlns:a16="http://schemas.microsoft.com/office/drawing/2014/main" id="{5FA8A402-FA68-4DBC-A748-076251095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="" xmlns:a16="http://schemas.microsoft.com/office/drawing/2014/main" id="{F3ADA592-873C-449C-9FA9-BAC4A6140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150002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="" xmlns:a16="http://schemas.microsoft.com/office/drawing/2014/main" id="{973BA4DB-7E27-47A0-B30A-AF94DA89B3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="" xmlns:a16="http://schemas.microsoft.com/office/drawing/2014/main" id="{964BB0EA-39B4-4E79-9B10-F986538B33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="" xmlns:a16="http://schemas.microsoft.com/office/drawing/2014/main" id="{E084B123-1E8E-4A69-ADB5-10D2F7CC6F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6ABFC2-EE90-4F1C-8675-73BEFC16085F}" type="datetimeFigureOut">
              <a:rPr lang="pt-BR" smtClean="0"/>
              <a:pPr/>
              <a:t>12/06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="" xmlns:a16="http://schemas.microsoft.com/office/drawing/2014/main" id="{ADC32C8A-1667-49A7-9EC1-03DF521939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="" xmlns:a16="http://schemas.microsoft.com/office/drawing/2014/main" id="{6DAEC808-4D58-4975-A9EE-D6C06D185D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53046-6747-4B87-90C8-D3C205735A7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436793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="" xmlns:a16="http://schemas.microsoft.com/office/drawing/2014/main" id="{2F6ED385-1852-48E7-A7D2-D8BC6E2B1C1B}"/>
              </a:ext>
            </a:extLst>
          </p:cNvPr>
          <p:cNvSpPr txBox="1"/>
          <p:nvPr/>
        </p:nvSpPr>
        <p:spPr>
          <a:xfrm rot="16200000">
            <a:off x="49929" y="2616361"/>
            <a:ext cx="284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b="1" dirty="0" err="1">
                <a:latin typeface="Arial" panose="020B0604020202020204" pitchFamily="34" charset="0"/>
                <a:cs typeface="Arial" panose="020B0604020202020204" pitchFamily="34" charset="0"/>
              </a:rPr>
              <a:t>Dry</a:t>
            </a:r>
            <a:r>
              <a:rPr lang="pt-BR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b="1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pt-BR" b="1" dirty="0">
                <a:latin typeface="Arial" panose="020B0604020202020204" pitchFamily="34" charset="0"/>
                <a:cs typeface="Arial" panose="020B0604020202020204" pitchFamily="34" charset="0"/>
              </a:rPr>
              <a:t> (mg)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="" xmlns:a16="http://schemas.microsoft.com/office/drawing/2014/main" id="{BA193242-F788-41F8-A83A-6F50F8660D65}"/>
              </a:ext>
            </a:extLst>
          </p:cNvPr>
          <p:cNvSpPr/>
          <p:nvPr/>
        </p:nvSpPr>
        <p:spPr>
          <a:xfrm>
            <a:off x="10648251" y="868806"/>
            <a:ext cx="144000" cy="144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6" name="Retângulo 15">
            <a:extLst>
              <a:ext uri="{FF2B5EF4-FFF2-40B4-BE49-F238E27FC236}">
                <a16:creationId xmlns="" xmlns:a16="http://schemas.microsoft.com/office/drawing/2014/main" id="{26540D4A-DC05-48E1-8EFC-6DD2046E9A02}"/>
              </a:ext>
            </a:extLst>
          </p:cNvPr>
          <p:cNvSpPr/>
          <p:nvPr/>
        </p:nvSpPr>
        <p:spPr>
          <a:xfrm>
            <a:off x="10648251" y="1233240"/>
            <a:ext cx="144000" cy="144000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0" name="CaixaDeTexto 9">
            <a:extLst>
              <a:ext uri="{FF2B5EF4-FFF2-40B4-BE49-F238E27FC236}">
                <a16:creationId xmlns="" xmlns:a16="http://schemas.microsoft.com/office/drawing/2014/main" id="{99A96B73-46F2-4D33-9564-99E9381D98C8}"/>
              </a:ext>
            </a:extLst>
          </p:cNvPr>
          <p:cNvSpPr txBox="1"/>
          <p:nvPr/>
        </p:nvSpPr>
        <p:spPr>
          <a:xfrm>
            <a:off x="10855567" y="756140"/>
            <a:ext cx="861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/>
              <a:t>24h</a:t>
            </a:r>
          </a:p>
        </p:txBody>
      </p:sp>
      <p:sp>
        <p:nvSpPr>
          <p:cNvPr id="17" name="CaixaDeTexto 16">
            <a:extLst>
              <a:ext uri="{FF2B5EF4-FFF2-40B4-BE49-F238E27FC236}">
                <a16:creationId xmlns="" xmlns:a16="http://schemas.microsoft.com/office/drawing/2014/main" id="{FF2E41F3-994A-4F54-82FF-0553BD246C0B}"/>
              </a:ext>
            </a:extLst>
          </p:cNvPr>
          <p:cNvSpPr txBox="1"/>
          <p:nvPr/>
        </p:nvSpPr>
        <p:spPr>
          <a:xfrm>
            <a:off x="10855567" y="1120574"/>
            <a:ext cx="861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/>
              <a:t>48h</a:t>
            </a:r>
          </a:p>
        </p:txBody>
      </p:sp>
      <p:graphicFrame>
        <p:nvGraphicFramePr>
          <p:cNvPr id="20" name="Gráfico 19">
            <a:extLst>
              <a:ext uri="{FF2B5EF4-FFF2-40B4-BE49-F238E27FC236}">
                <a16:creationId xmlns="" xmlns:a16="http://schemas.microsoft.com/office/drawing/2014/main" id="{A09A7C37-352A-423E-BF6F-0337BE8682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260124508"/>
              </p:ext>
            </p:extLst>
          </p:nvPr>
        </p:nvGraphicFramePr>
        <p:xfrm>
          <a:off x="1639740" y="394044"/>
          <a:ext cx="9204065" cy="56988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CaixaDeTexto 5">
            <a:extLst>
              <a:ext uri="{FF2B5EF4-FFF2-40B4-BE49-F238E27FC236}">
                <a16:creationId xmlns="" xmlns:a16="http://schemas.microsoft.com/office/drawing/2014/main" id="{9C31D774-F337-4B09-8676-DAAA55B419A2}"/>
              </a:ext>
            </a:extLst>
          </p:cNvPr>
          <p:cNvSpPr txBox="1"/>
          <p:nvPr/>
        </p:nvSpPr>
        <p:spPr>
          <a:xfrm>
            <a:off x="2125881" y="5783453"/>
            <a:ext cx="153170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t-BR" b="1" dirty="0" err="1" smtClean="0"/>
              <a:t>Wild-type</a:t>
            </a:r>
            <a:endParaRPr lang="pt-BR" b="1" dirty="0"/>
          </a:p>
        </p:txBody>
      </p:sp>
      <p:sp>
        <p:nvSpPr>
          <p:cNvPr id="7" name="CaixaDeTexto 6">
            <a:extLst>
              <a:ext uri="{FF2B5EF4-FFF2-40B4-BE49-F238E27FC236}">
                <a16:creationId xmlns="" xmlns:a16="http://schemas.microsoft.com/office/drawing/2014/main" id="{038C2CE9-1C19-45BD-9F88-55A5777F0638}"/>
              </a:ext>
            </a:extLst>
          </p:cNvPr>
          <p:cNvSpPr txBox="1"/>
          <p:nvPr/>
        </p:nvSpPr>
        <p:spPr>
          <a:xfrm>
            <a:off x="3842619" y="5789825"/>
            <a:ext cx="9300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l-GR" b="1" dirty="0"/>
              <a:t>Δ</a:t>
            </a:r>
            <a:r>
              <a:rPr lang="pt-BR" b="1" i="1" dirty="0" err="1"/>
              <a:t>gprM</a:t>
            </a:r>
            <a:endParaRPr lang="pt-BR" b="1" i="1" dirty="0"/>
          </a:p>
        </p:txBody>
      </p:sp>
      <p:sp>
        <p:nvSpPr>
          <p:cNvPr id="8" name="CaixaDeTexto 7">
            <a:extLst>
              <a:ext uri="{FF2B5EF4-FFF2-40B4-BE49-F238E27FC236}">
                <a16:creationId xmlns="" xmlns:a16="http://schemas.microsoft.com/office/drawing/2014/main" id="{C254DA5E-33C5-4244-BA97-CA9DE508E45C}"/>
              </a:ext>
            </a:extLst>
          </p:cNvPr>
          <p:cNvSpPr txBox="1"/>
          <p:nvPr/>
        </p:nvSpPr>
        <p:spPr>
          <a:xfrm>
            <a:off x="4923172" y="5789825"/>
            <a:ext cx="162379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l-GR" b="1" dirty="0"/>
              <a:t>Δ</a:t>
            </a:r>
            <a:r>
              <a:rPr lang="pt-BR" b="1" i="1" dirty="0" err="1" smtClean="0"/>
              <a:t>gprM</a:t>
            </a:r>
            <a:r>
              <a:rPr lang="pt-BR" b="1" dirty="0" smtClean="0"/>
              <a:t>::</a:t>
            </a:r>
            <a:r>
              <a:rPr lang="pt-BR" b="1" i="1" dirty="0" err="1" smtClean="0"/>
              <a:t>gprM</a:t>
            </a:r>
            <a:r>
              <a:rPr lang="pt-BR" b="1" i="1" baseline="30000" dirty="0" smtClean="0"/>
              <a:t>+</a:t>
            </a:r>
            <a:endParaRPr lang="pt-BR" b="1" i="1" dirty="0"/>
          </a:p>
        </p:txBody>
      </p:sp>
      <p:sp>
        <p:nvSpPr>
          <p:cNvPr id="14" name="CaixaDeTexto 13">
            <a:extLst>
              <a:ext uri="{FF2B5EF4-FFF2-40B4-BE49-F238E27FC236}">
                <a16:creationId xmlns="" xmlns:a16="http://schemas.microsoft.com/office/drawing/2014/main" id="{CDA4C603-164D-4228-8BA0-716A41AEF198}"/>
              </a:ext>
            </a:extLst>
          </p:cNvPr>
          <p:cNvSpPr txBox="1"/>
          <p:nvPr/>
        </p:nvSpPr>
        <p:spPr>
          <a:xfrm>
            <a:off x="6679175" y="5789825"/>
            <a:ext cx="9300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l-GR" b="1" dirty="0"/>
              <a:t>Δ</a:t>
            </a:r>
            <a:r>
              <a:rPr lang="pt-BR" b="1" i="1" dirty="0" err="1"/>
              <a:t>gprJ</a:t>
            </a:r>
            <a:endParaRPr lang="pt-BR" b="1" i="1" dirty="0"/>
          </a:p>
        </p:txBody>
      </p:sp>
      <p:sp>
        <p:nvSpPr>
          <p:cNvPr id="15" name="CaixaDeTexto 14">
            <a:extLst>
              <a:ext uri="{FF2B5EF4-FFF2-40B4-BE49-F238E27FC236}">
                <a16:creationId xmlns="" xmlns:a16="http://schemas.microsoft.com/office/drawing/2014/main" id="{C8428978-A181-47D4-8D8F-365A057D83A1}"/>
              </a:ext>
            </a:extLst>
          </p:cNvPr>
          <p:cNvSpPr txBox="1"/>
          <p:nvPr/>
        </p:nvSpPr>
        <p:spPr>
          <a:xfrm>
            <a:off x="7770528" y="5789825"/>
            <a:ext cx="162379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l-GR" b="1" dirty="0"/>
              <a:t>Δ</a:t>
            </a:r>
            <a:r>
              <a:rPr lang="pt-BR" b="1" i="1" dirty="0" err="1" smtClean="0"/>
              <a:t>gprJ</a:t>
            </a:r>
            <a:r>
              <a:rPr lang="pt-BR" b="1" dirty="0" smtClean="0"/>
              <a:t>::</a:t>
            </a:r>
            <a:r>
              <a:rPr lang="pt-BR" b="1" i="1" dirty="0" err="1" smtClean="0"/>
              <a:t>gprJ</a:t>
            </a:r>
            <a:r>
              <a:rPr lang="pt-BR" b="1" i="1" baseline="30000" dirty="0" smtClean="0"/>
              <a:t>+</a:t>
            </a:r>
            <a:endParaRPr lang="pt-BR" b="1" i="1" dirty="0"/>
          </a:p>
        </p:txBody>
      </p:sp>
      <p:sp>
        <p:nvSpPr>
          <p:cNvPr id="9" name="CaixaDeTexto 8">
            <a:extLst>
              <a:ext uri="{FF2B5EF4-FFF2-40B4-BE49-F238E27FC236}">
                <a16:creationId xmlns="" xmlns:a16="http://schemas.microsoft.com/office/drawing/2014/main" id="{F0E5C4F2-338D-45AA-90EF-1FD43E128B27}"/>
              </a:ext>
            </a:extLst>
          </p:cNvPr>
          <p:cNvSpPr txBox="1"/>
          <p:nvPr/>
        </p:nvSpPr>
        <p:spPr>
          <a:xfrm>
            <a:off x="9166677" y="5789825"/>
            <a:ext cx="16658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l-GR" b="1" dirty="0"/>
              <a:t>Δ</a:t>
            </a:r>
            <a:r>
              <a:rPr lang="pt-BR" b="1" i="1" dirty="0" err="1" smtClean="0"/>
              <a:t>gprM</a:t>
            </a:r>
            <a:r>
              <a:rPr lang="pt-BR" b="1" i="1" dirty="0" smtClean="0"/>
              <a:t> </a:t>
            </a:r>
            <a:r>
              <a:rPr lang="el-GR" b="1" dirty="0" smtClean="0"/>
              <a:t>Δ</a:t>
            </a:r>
            <a:r>
              <a:rPr lang="pt-BR" b="1" i="1" dirty="0" err="1" smtClean="0"/>
              <a:t>gprJ</a:t>
            </a:r>
            <a:endParaRPr lang="pt-BR" b="1" i="1" dirty="0"/>
          </a:p>
        </p:txBody>
      </p:sp>
      <p:sp>
        <p:nvSpPr>
          <p:cNvPr id="18" name="CaixaDeTexto 17"/>
          <p:cNvSpPr txBox="1"/>
          <p:nvPr/>
        </p:nvSpPr>
        <p:spPr>
          <a:xfrm>
            <a:off x="304800" y="481263"/>
            <a:ext cx="50751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3000" dirty="0" smtClean="0"/>
              <a:t>A.</a:t>
            </a:r>
            <a:endParaRPr lang="pt-BR" sz="3000" dirty="0"/>
          </a:p>
        </p:txBody>
      </p:sp>
    </p:spTree>
    <p:extLst>
      <p:ext uri="{BB962C8B-B14F-4D97-AF65-F5344CB8AC3E}">
        <p14:creationId xmlns="" xmlns:p14="http://schemas.microsoft.com/office/powerpoint/2010/main" val="3698663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ixaDeTexto 13">
            <a:extLst>
              <a:ext uri="{FF2B5EF4-FFF2-40B4-BE49-F238E27FC236}">
                <a16:creationId xmlns="" xmlns:a16="http://schemas.microsoft.com/office/drawing/2014/main" id="{3A3E8078-CB38-479C-B0AC-A5669E0DE8FD}"/>
              </a:ext>
            </a:extLst>
          </p:cNvPr>
          <p:cNvSpPr txBox="1"/>
          <p:nvPr/>
        </p:nvSpPr>
        <p:spPr>
          <a:xfrm rot="16200000">
            <a:off x="-188255" y="3102821"/>
            <a:ext cx="25690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b="1" dirty="0" err="1"/>
              <a:t>Extracelullar</a:t>
            </a:r>
            <a:r>
              <a:rPr lang="pt-BR" b="1" dirty="0"/>
              <a:t> glucose (%)</a:t>
            </a:r>
          </a:p>
        </p:txBody>
      </p:sp>
      <p:sp>
        <p:nvSpPr>
          <p:cNvPr id="23" name="CaixaDeTexto 22">
            <a:extLst>
              <a:ext uri="{FF2B5EF4-FFF2-40B4-BE49-F238E27FC236}">
                <a16:creationId xmlns="" xmlns:a16="http://schemas.microsoft.com/office/drawing/2014/main" id="{004A7151-AA6F-451D-8F23-94FAB3C702DC}"/>
              </a:ext>
            </a:extLst>
          </p:cNvPr>
          <p:cNvSpPr txBox="1"/>
          <p:nvPr/>
        </p:nvSpPr>
        <p:spPr>
          <a:xfrm>
            <a:off x="4648685" y="6251531"/>
            <a:ext cx="25690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b="1" dirty="0"/>
              <a:t>Time (h)</a:t>
            </a:r>
          </a:p>
        </p:txBody>
      </p:sp>
      <p:graphicFrame>
        <p:nvGraphicFramePr>
          <p:cNvPr id="18" name="Gráfico 17">
            <a:extLst>
              <a:ext uri="{FF2B5EF4-FFF2-40B4-BE49-F238E27FC236}">
                <a16:creationId xmlns="" xmlns:a16="http://schemas.microsoft.com/office/drawing/2014/main" id="{34F1003B-ED05-4055-9D19-D76397028F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842666540"/>
              </p:ext>
            </p:extLst>
          </p:nvPr>
        </p:nvGraphicFramePr>
        <p:xfrm>
          <a:off x="1243641" y="550653"/>
          <a:ext cx="9704717" cy="57566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0" name="CaixaDeTexto 19">
            <a:extLst>
              <a:ext uri="{FF2B5EF4-FFF2-40B4-BE49-F238E27FC236}">
                <a16:creationId xmlns="" xmlns:a16="http://schemas.microsoft.com/office/drawing/2014/main" id="{88458170-6A91-4AD9-A59D-4F076DACCD09}"/>
              </a:ext>
            </a:extLst>
          </p:cNvPr>
          <p:cNvSpPr txBox="1"/>
          <p:nvPr/>
        </p:nvSpPr>
        <p:spPr>
          <a:xfrm>
            <a:off x="9386664" y="793399"/>
            <a:ext cx="148453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BR" smtClean="0"/>
              <a:t>Wild-type</a:t>
            </a:r>
            <a:endParaRPr lang="pt-BR" dirty="0"/>
          </a:p>
        </p:txBody>
      </p:sp>
      <p:sp>
        <p:nvSpPr>
          <p:cNvPr id="21" name="CaixaDeTexto 20">
            <a:extLst>
              <a:ext uri="{FF2B5EF4-FFF2-40B4-BE49-F238E27FC236}">
                <a16:creationId xmlns="" xmlns:a16="http://schemas.microsoft.com/office/drawing/2014/main" id="{0162CC83-1638-4339-B7A8-DCAC5892D77E}"/>
              </a:ext>
            </a:extLst>
          </p:cNvPr>
          <p:cNvSpPr txBox="1"/>
          <p:nvPr/>
        </p:nvSpPr>
        <p:spPr>
          <a:xfrm>
            <a:off x="9386664" y="1195374"/>
            <a:ext cx="9300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dirty="0"/>
              <a:t>Δ</a:t>
            </a:r>
            <a:r>
              <a:rPr lang="pt-BR" i="1" dirty="0" err="1"/>
              <a:t>gprM</a:t>
            </a:r>
            <a:endParaRPr lang="pt-BR" i="1" dirty="0"/>
          </a:p>
        </p:txBody>
      </p:sp>
      <p:sp>
        <p:nvSpPr>
          <p:cNvPr id="35" name="CaixaDeTexto 34">
            <a:extLst>
              <a:ext uri="{FF2B5EF4-FFF2-40B4-BE49-F238E27FC236}">
                <a16:creationId xmlns="" xmlns:a16="http://schemas.microsoft.com/office/drawing/2014/main" id="{0AC20172-A6CE-43A3-9AF6-7C7B78364F82}"/>
              </a:ext>
            </a:extLst>
          </p:cNvPr>
          <p:cNvSpPr txBox="1"/>
          <p:nvPr/>
        </p:nvSpPr>
        <p:spPr>
          <a:xfrm>
            <a:off x="9386664" y="1661448"/>
            <a:ext cx="162379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dirty="0"/>
              <a:t>Δ</a:t>
            </a:r>
            <a:r>
              <a:rPr lang="pt-BR" i="1" dirty="0" err="1" smtClean="0"/>
              <a:t>gprM</a:t>
            </a:r>
            <a:r>
              <a:rPr lang="pt-BR" dirty="0" smtClean="0"/>
              <a:t>::</a:t>
            </a:r>
            <a:r>
              <a:rPr lang="pt-BR" i="1" dirty="0" err="1" smtClean="0"/>
              <a:t>gprM</a:t>
            </a:r>
            <a:r>
              <a:rPr lang="pt-BR" i="1" baseline="30000" dirty="0" smtClean="0"/>
              <a:t>+</a:t>
            </a:r>
            <a:endParaRPr lang="pt-BR" i="1" dirty="0"/>
          </a:p>
        </p:txBody>
      </p:sp>
      <p:sp>
        <p:nvSpPr>
          <p:cNvPr id="36" name="CaixaDeTexto 35">
            <a:extLst>
              <a:ext uri="{FF2B5EF4-FFF2-40B4-BE49-F238E27FC236}">
                <a16:creationId xmlns="" xmlns:a16="http://schemas.microsoft.com/office/drawing/2014/main" id="{AFC4168A-5CCB-427E-B50A-A119CD8B41C1}"/>
              </a:ext>
            </a:extLst>
          </p:cNvPr>
          <p:cNvSpPr txBox="1"/>
          <p:nvPr/>
        </p:nvSpPr>
        <p:spPr>
          <a:xfrm>
            <a:off x="9386664" y="2127522"/>
            <a:ext cx="9300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dirty="0"/>
              <a:t>Δ</a:t>
            </a:r>
            <a:r>
              <a:rPr lang="pt-BR" i="1" dirty="0" err="1"/>
              <a:t>gprJ</a:t>
            </a:r>
            <a:endParaRPr lang="pt-BR" i="1" dirty="0"/>
          </a:p>
        </p:txBody>
      </p:sp>
      <p:sp>
        <p:nvSpPr>
          <p:cNvPr id="37" name="CaixaDeTexto 36">
            <a:extLst>
              <a:ext uri="{FF2B5EF4-FFF2-40B4-BE49-F238E27FC236}">
                <a16:creationId xmlns="" xmlns:a16="http://schemas.microsoft.com/office/drawing/2014/main" id="{4AECBF4D-BC0A-4948-ADE7-96DBB2CD4E30}"/>
              </a:ext>
            </a:extLst>
          </p:cNvPr>
          <p:cNvSpPr txBox="1"/>
          <p:nvPr/>
        </p:nvSpPr>
        <p:spPr>
          <a:xfrm>
            <a:off x="9386664" y="2593596"/>
            <a:ext cx="162379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dirty="0"/>
              <a:t>Δ</a:t>
            </a:r>
            <a:r>
              <a:rPr lang="pt-BR" i="1" dirty="0" err="1" smtClean="0"/>
              <a:t>gprJ</a:t>
            </a:r>
            <a:r>
              <a:rPr lang="pt-BR" dirty="0" smtClean="0"/>
              <a:t>::</a:t>
            </a:r>
            <a:r>
              <a:rPr lang="pt-BR" i="1" dirty="0" err="1" smtClean="0"/>
              <a:t>gprJ</a:t>
            </a:r>
            <a:r>
              <a:rPr lang="pt-BR" i="1" baseline="30000" dirty="0" smtClean="0"/>
              <a:t>+</a:t>
            </a:r>
            <a:endParaRPr lang="pt-BR" i="1" dirty="0"/>
          </a:p>
        </p:txBody>
      </p:sp>
      <p:sp>
        <p:nvSpPr>
          <p:cNvPr id="38" name="CaixaDeTexto 37">
            <a:extLst>
              <a:ext uri="{FF2B5EF4-FFF2-40B4-BE49-F238E27FC236}">
                <a16:creationId xmlns="" xmlns:a16="http://schemas.microsoft.com/office/drawing/2014/main" id="{9B08F882-272A-4738-85B7-52EEDD265661}"/>
              </a:ext>
            </a:extLst>
          </p:cNvPr>
          <p:cNvSpPr txBox="1"/>
          <p:nvPr/>
        </p:nvSpPr>
        <p:spPr>
          <a:xfrm>
            <a:off x="9386664" y="3059668"/>
            <a:ext cx="16658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dirty="0"/>
              <a:t>Δ</a:t>
            </a:r>
            <a:r>
              <a:rPr lang="pt-BR" i="1" dirty="0" err="1" smtClean="0"/>
              <a:t>gprM</a:t>
            </a:r>
            <a:r>
              <a:rPr lang="pt-BR" dirty="0" smtClean="0"/>
              <a:t> </a:t>
            </a:r>
            <a:r>
              <a:rPr lang="el-GR" dirty="0"/>
              <a:t>Δ</a:t>
            </a:r>
            <a:r>
              <a:rPr lang="pt-BR" i="1" dirty="0" err="1" smtClean="0"/>
              <a:t>gprJ</a:t>
            </a:r>
            <a:endParaRPr lang="pt-BR" i="1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04800" y="481263"/>
            <a:ext cx="49244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3000" dirty="0" smtClean="0"/>
              <a:t>B</a:t>
            </a:r>
            <a:r>
              <a:rPr lang="pt-BR" sz="3000" smtClean="0"/>
              <a:t>.</a:t>
            </a:r>
            <a:endParaRPr lang="pt-BR" sz="3000" dirty="0"/>
          </a:p>
        </p:txBody>
      </p:sp>
    </p:spTree>
    <p:extLst>
      <p:ext uri="{BB962C8B-B14F-4D97-AF65-F5344CB8AC3E}">
        <p14:creationId xmlns="" xmlns:p14="http://schemas.microsoft.com/office/powerpoint/2010/main" val="36601247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5</TotalTime>
  <Words>56</Words>
  <Application>Microsoft Office PowerPoint</Application>
  <PresentationFormat>Personalizar</PresentationFormat>
  <Paragraphs>19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2</vt:i4>
      </vt:variant>
    </vt:vector>
  </HeadingPairs>
  <TitlesOfParts>
    <vt:vector size="3" baseType="lpstr">
      <vt:lpstr>Tema do Offic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Thaila Reis</dc:creator>
  <cp:lastModifiedBy>ggoldman</cp:lastModifiedBy>
  <cp:revision>16</cp:revision>
  <dcterms:created xsi:type="dcterms:W3CDTF">2020-05-23T21:13:49Z</dcterms:created>
  <dcterms:modified xsi:type="dcterms:W3CDTF">2020-06-12T23:20:29Z</dcterms:modified>
</cp:coreProperties>
</file>